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14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418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427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43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513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63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4339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403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73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2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900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93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F5DD1-F976-4575-AA6B-758620391F24}" type="datetimeFigureOut">
              <a:rPr lang="en-US" smtClean="0"/>
              <a:t>1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BEB89-9250-4983-A893-65C4A92294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677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13" Type="http://schemas.openxmlformats.org/officeDocument/2006/relationships/image" Target="../media/image26.emf"/><Relationship Id="rId18" Type="http://schemas.openxmlformats.org/officeDocument/2006/relationships/image" Target="../media/image31.emf"/><Relationship Id="rId26" Type="http://schemas.openxmlformats.org/officeDocument/2006/relationships/image" Target="../media/image39.emf"/><Relationship Id="rId3" Type="http://schemas.openxmlformats.org/officeDocument/2006/relationships/image" Target="../media/image16.emf"/><Relationship Id="rId21" Type="http://schemas.openxmlformats.org/officeDocument/2006/relationships/image" Target="../media/image34.emf"/><Relationship Id="rId7" Type="http://schemas.openxmlformats.org/officeDocument/2006/relationships/image" Target="../media/image20.emf"/><Relationship Id="rId12" Type="http://schemas.openxmlformats.org/officeDocument/2006/relationships/image" Target="../media/image25.emf"/><Relationship Id="rId17" Type="http://schemas.openxmlformats.org/officeDocument/2006/relationships/image" Target="../media/image30.emf"/><Relationship Id="rId25" Type="http://schemas.openxmlformats.org/officeDocument/2006/relationships/image" Target="../media/image38.emf"/><Relationship Id="rId2" Type="http://schemas.openxmlformats.org/officeDocument/2006/relationships/image" Target="../media/image15.emf"/><Relationship Id="rId16" Type="http://schemas.openxmlformats.org/officeDocument/2006/relationships/image" Target="../media/image29.emf"/><Relationship Id="rId20" Type="http://schemas.openxmlformats.org/officeDocument/2006/relationships/image" Target="../media/image33.emf"/><Relationship Id="rId29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emf"/><Relationship Id="rId11" Type="http://schemas.openxmlformats.org/officeDocument/2006/relationships/image" Target="../media/image24.emf"/><Relationship Id="rId24" Type="http://schemas.openxmlformats.org/officeDocument/2006/relationships/image" Target="../media/image37.emf"/><Relationship Id="rId5" Type="http://schemas.openxmlformats.org/officeDocument/2006/relationships/image" Target="../media/image18.emf"/><Relationship Id="rId15" Type="http://schemas.openxmlformats.org/officeDocument/2006/relationships/image" Target="../media/image28.emf"/><Relationship Id="rId23" Type="http://schemas.openxmlformats.org/officeDocument/2006/relationships/image" Target="../media/image36.emf"/><Relationship Id="rId28" Type="http://schemas.openxmlformats.org/officeDocument/2006/relationships/image" Target="../media/image41.emf"/><Relationship Id="rId10" Type="http://schemas.openxmlformats.org/officeDocument/2006/relationships/image" Target="../media/image23.emf"/><Relationship Id="rId19" Type="http://schemas.openxmlformats.org/officeDocument/2006/relationships/image" Target="../media/image32.emf"/><Relationship Id="rId31" Type="http://schemas.openxmlformats.org/officeDocument/2006/relationships/image" Target="../media/image44.emf"/><Relationship Id="rId4" Type="http://schemas.openxmlformats.org/officeDocument/2006/relationships/image" Target="../media/image17.emf"/><Relationship Id="rId9" Type="http://schemas.openxmlformats.org/officeDocument/2006/relationships/image" Target="../media/image22.emf"/><Relationship Id="rId14" Type="http://schemas.openxmlformats.org/officeDocument/2006/relationships/image" Target="../media/image27.emf"/><Relationship Id="rId22" Type="http://schemas.openxmlformats.org/officeDocument/2006/relationships/image" Target="../media/image35.emf"/><Relationship Id="rId27" Type="http://schemas.openxmlformats.org/officeDocument/2006/relationships/image" Target="../media/image40.emf"/><Relationship Id="rId30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850" y="4047193"/>
            <a:ext cx="1645920" cy="1581532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690247" y="79674"/>
            <a:ext cx="62537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1. Gating Strategy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89483" y="633227"/>
            <a:ext cx="6019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IR</a:t>
            </a:r>
            <a:endParaRPr lang="en-US" b="1" dirty="0"/>
          </a:p>
        </p:txBody>
      </p:sp>
      <p:grpSp>
        <p:nvGrpSpPr>
          <p:cNvPr id="54" name="Group 53"/>
          <p:cNvGrpSpPr/>
          <p:nvPr/>
        </p:nvGrpSpPr>
        <p:grpSpPr>
          <a:xfrm>
            <a:off x="238866" y="96273"/>
            <a:ext cx="11776744" cy="6613436"/>
            <a:chOff x="238866" y="96273"/>
            <a:chExt cx="11776744" cy="661343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8866" y="937755"/>
              <a:ext cx="1645920" cy="1640105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968289" y="977969"/>
              <a:ext cx="1645920" cy="148824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52642" y="995760"/>
              <a:ext cx="2011680" cy="1351569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03173" y="999006"/>
              <a:ext cx="2103120" cy="1487569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010287" y="909182"/>
              <a:ext cx="1828800" cy="1545418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781623" y="96273"/>
              <a:ext cx="1828800" cy="1625816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781623" y="1690686"/>
              <a:ext cx="1893023" cy="1645920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968289" y="4023340"/>
              <a:ext cx="1645920" cy="1488242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752642" y="4121883"/>
              <a:ext cx="2011680" cy="140946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803173" y="4195403"/>
              <a:ext cx="2011680" cy="1475585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981586" y="4142330"/>
              <a:ext cx="1828800" cy="1548982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9829843" y="3305204"/>
              <a:ext cx="1828800" cy="1703882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9852818" y="4969373"/>
              <a:ext cx="1828800" cy="1740336"/>
            </a:xfrm>
            <a:prstGeom prst="rect">
              <a:avLst/>
            </a:prstGeom>
          </p:spPr>
        </p:pic>
        <p:cxnSp>
          <p:nvCxnSpPr>
            <p:cNvPr id="24" name="Straight Arrow Connector 23"/>
            <p:cNvCxnSpPr/>
            <p:nvPr/>
          </p:nvCxnSpPr>
          <p:spPr>
            <a:xfrm>
              <a:off x="1137229" y="1710452"/>
              <a:ext cx="964945" cy="185515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/>
            <p:cNvCxnSpPr/>
            <p:nvPr/>
          </p:nvCxnSpPr>
          <p:spPr>
            <a:xfrm>
              <a:off x="1119614" y="4725537"/>
              <a:ext cx="964945" cy="185515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443388" y="2879569"/>
              <a:ext cx="13233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Singlet gate</a:t>
              </a:r>
              <a:endParaRPr lang="en-US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62634" y="3654008"/>
              <a:ext cx="6019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INR</a:t>
              </a:r>
              <a:endParaRPr lang="en-US" b="1" dirty="0"/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 flipV="1">
              <a:off x="2872711" y="1803209"/>
              <a:ext cx="938794" cy="244393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 flipV="1">
              <a:off x="2951591" y="4911052"/>
              <a:ext cx="898515" cy="142446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102174" y="2879569"/>
              <a:ext cx="132335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lymphocyte gate</a:t>
              </a:r>
              <a:endParaRPr lang="en-US" dirty="0"/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 flipV="1">
              <a:off x="4473975" y="1551344"/>
              <a:ext cx="1411335" cy="314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>
            <a:xfrm flipV="1">
              <a:off x="4617185" y="4671332"/>
              <a:ext cx="1268125" cy="1096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4009864" y="2848169"/>
              <a:ext cx="132335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Live/Dead gate</a:t>
              </a:r>
              <a:endParaRPr lang="en-US" dirty="0"/>
            </a:p>
          </p:txBody>
        </p:sp>
        <p:cxnSp>
          <p:nvCxnSpPr>
            <p:cNvPr id="40" name="Straight Arrow Connector 39"/>
            <p:cNvCxnSpPr/>
            <p:nvPr/>
          </p:nvCxnSpPr>
          <p:spPr>
            <a:xfrm flipV="1">
              <a:off x="6908518" y="1579679"/>
              <a:ext cx="1132612" cy="383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V="1">
              <a:off x="6844953" y="4750994"/>
              <a:ext cx="1132612" cy="383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6055404" y="2986784"/>
              <a:ext cx="18262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D3/ T cell gate</a:t>
              </a:r>
              <a:endParaRPr lang="en-US" dirty="0"/>
            </a:p>
          </p:txBody>
        </p:sp>
        <p:sp>
          <p:nvSpPr>
            <p:cNvPr id="44" name="TextBox 43"/>
            <p:cNvSpPr txBox="1"/>
            <p:nvPr/>
          </p:nvSpPr>
          <p:spPr>
            <a:xfrm rot="5400000">
              <a:off x="10349064" y="2848558"/>
              <a:ext cx="29637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Maturation Subset gating</a:t>
              </a:r>
              <a:endParaRPr lang="en-US" dirty="0"/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 flipV="1">
              <a:off x="8598234" y="909182"/>
              <a:ext cx="1254584" cy="544456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>
              <a:off x="9315113" y="1889236"/>
              <a:ext cx="510242" cy="624411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>
              <a:endCxn id="20" idx="1"/>
            </p:cNvCxnSpPr>
            <p:nvPr/>
          </p:nvCxnSpPr>
          <p:spPr>
            <a:xfrm flipV="1">
              <a:off x="8608918" y="4157145"/>
              <a:ext cx="1220925" cy="568392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>
              <a:off x="9219380" y="5076298"/>
              <a:ext cx="633438" cy="739389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8263010" y="2883214"/>
              <a:ext cx="132335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/>
                <a:t>CD4 CD8 gating</a:t>
              </a:r>
              <a:endParaRPr lang="en-US" dirty="0"/>
            </a:p>
          </p:txBody>
        </p:sp>
      </p:grpSp>
      <p:sp>
        <p:nvSpPr>
          <p:cNvPr id="55" name="TextBox 54"/>
          <p:cNvSpPr txBox="1"/>
          <p:nvPr/>
        </p:nvSpPr>
        <p:spPr>
          <a:xfrm>
            <a:off x="971174" y="374694"/>
            <a:ext cx="2581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 </a:t>
            </a:r>
            <a:r>
              <a:rPr lang="en-US" dirty="0"/>
              <a:t>cell Maturation Subsets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61676" y="389271"/>
            <a:ext cx="450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1063222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1725" y="4728864"/>
            <a:ext cx="1645920" cy="981140"/>
          </a:xfrm>
          <a:prstGeom prst="rect">
            <a:avLst/>
          </a:prstGeom>
        </p:spPr>
      </p:pic>
      <p:pic>
        <p:nvPicPr>
          <p:cNvPr id="33" name="Picture 3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131665" y="4738054"/>
            <a:ext cx="1645920" cy="100584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31725" y="5716708"/>
            <a:ext cx="1645920" cy="1121294"/>
          </a:xfrm>
          <a:prstGeom prst="rect">
            <a:avLst/>
          </a:prstGeom>
        </p:spPr>
      </p:pic>
      <p:pic>
        <p:nvPicPr>
          <p:cNvPr id="35" name="Picture 34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5126765" y="5739683"/>
            <a:ext cx="1645920" cy="109728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47500" y="3739032"/>
            <a:ext cx="1645920" cy="985501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26485" y="3726398"/>
            <a:ext cx="1645920" cy="1028791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38939" y="1047658"/>
            <a:ext cx="810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Isotype</a:t>
            </a:r>
            <a:endParaRPr lang="en-US" sz="1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38614" y="1852548"/>
            <a:ext cx="9963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D4 blue</a:t>
            </a:r>
          </a:p>
          <a:p>
            <a:r>
              <a:rPr lang="en-US" sz="1600" b="1" dirty="0" smtClean="0"/>
              <a:t>CD8 pink</a:t>
            </a:r>
            <a:endParaRPr lang="en-US" sz="16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39279" y="2775942"/>
            <a:ext cx="11462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Maturation</a:t>
            </a:r>
          </a:p>
          <a:p>
            <a:pPr algn="ctr"/>
            <a:r>
              <a:rPr lang="en-US" sz="1600" b="1" dirty="0" smtClean="0"/>
              <a:t>subsets</a:t>
            </a:r>
          </a:p>
        </p:txBody>
      </p:sp>
      <p:grpSp>
        <p:nvGrpSpPr>
          <p:cNvPr id="67" name="Group 66"/>
          <p:cNvGrpSpPr/>
          <p:nvPr/>
        </p:nvGrpSpPr>
        <p:grpSpPr>
          <a:xfrm>
            <a:off x="1182665" y="487070"/>
            <a:ext cx="2659016" cy="3170754"/>
            <a:chOff x="1182665" y="91900"/>
            <a:chExt cx="2659016" cy="3170754"/>
          </a:xfrm>
        </p:grpSpPr>
        <p:grpSp>
          <p:nvGrpSpPr>
            <p:cNvPr id="38" name="Group 37"/>
            <p:cNvGrpSpPr/>
            <p:nvPr/>
          </p:nvGrpSpPr>
          <p:grpSpPr>
            <a:xfrm>
              <a:off x="1187260" y="437684"/>
              <a:ext cx="1377437" cy="2732926"/>
              <a:chOff x="920750" y="147100"/>
              <a:chExt cx="1377437" cy="2732926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20750" y="1004869"/>
                <a:ext cx="1377437" cy="942187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963068" y="1949876"/>
                <a:ext cx="1280160" cy="930150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964976" y="147100"/>
                <a:ext cx="1307398" cy="854948"/>
              </a:xfrm>
              <a:prstGeom prst="rect">
                <a:avLst/>
              </a:prstGeom>
            </p:spPr>
          </p:pic>
        </p:grpSp>
        <p:grpSp>
          <p:nvGrpSpPr>
            <p:cNvPr id="43" name="Group 42"/>
            <p:cNvGrpSpPr/>
            <p:nvPr/>
          </p:nvGrpSpPr>
          <p:grpSpPr>
            <a:xfrm>
              <a:off x="2479249" y="445305"/>
              <a:ext cx="1362432" cy="2704254"/>
              <a:chOff x="2224667" y="154721"/>
              <a:chExt cx="1362432" cy="2704254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224667" y="1076143"/>
                <a:ext cx="1330744" cy="854948"/>
              </a:xfrm>
              <a:prstGeom prst="rect">
                <a:avLst/>
              </a:prstGeom>
            </p:spPr>
          </p:pic>
          <p:pic>
            <p:nvPicPr>
              <p:cNvPr id="5" name="Picture 4"/>
              <p:cNvPicPr preferRelativeResize="0">
                <a:picLocks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227221" y="2004362"/>
                <a:ext cx="1280160" cy="854613"/>
              </a:xfrm>
              <a:prstGeom prst="rect">
                <a:avLst/>
              </a:prstGeom>
            </p:spPr>
          </p:pic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279701" y="154721"/>
                <a:ext cx="1307398" cy="872395"/>
              </a:xfrm>
              <a:prstGeom prst="rect">
                <a:avLst/>
              </a:prstGeom>
            </p:spPr>
          </p:pic>
        </p:grpSp>
        <p:sp>
          <p:nvSpPr>
            <p:cNvPr id="49" name="Rectangle 48"/>
            <p:cNvSpPr/>
            <p:nvPr/>
          </p:nvSpPr>
          <p:spPr>
            <a:xfrm>
              <a:off x="1182665" y="91900"/>
              <a:ext cx="2610595" cy="317075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278408" y="95920"/>
              <a:ext cx="6785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PD-1</a:t>
              </a:r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6372714" y="491666"/>
            <a:ext cx="2613377" cy="3170042"/>
            <a:chOff x="6372714" y="91901"/>
            <a:chExt cx="2613377" cy="3170042"/>
          </a:xfrm>
        </p:grpSpPr>
        <p:grpSp>
          <p:nvGrpSpPr>
            <p:cNvPr id="57" name="Group 56"/>
            <p:cNvGrpSpPr/>
            <p:nvPr/>
          </p:nvGrpSpPr>
          <p:grpSpPr>
            <a:xfrm>
              <a:off x="6420508" y="425826"/>
              <a:ext cx="1391449" cy="2666916"/>
              <a:chOff x="6153998" y="136341"/>
              <a:chExt cx="1391449" cy="2666916"/>
            </a:xfrm>
          </p:grpSpPr>
          <p:pic>
            <p:nvPicPr>
              <p:cNvPr id="10" name="Picture 9"/>
              <p:cNvPicPr preferRelativeResize="0"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6156770" y="1042411"/>
                <a:ext cx="1280160" cy="849132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 preferRelativeResize="0">
                <a:picLocks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6153998" y="1980297"/>
                <a:ext cx="1280160" cy="822960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6173847" y="136341"/>
                <a:ext cx="1371600" cy="848525"/>
              </a:xfrm>
              <a:prstGeom prst="rect">
                <a:avLst/>
              </a:prstGeom>
            </p:spPr>
          </p:pic>
        </p:grpSp>
        <p:grpSp>
          <p:nvGrpSpPr>
            <p:cNvPr id="55" name="Group 54"/>
            <p:cNvGrpSpPr/>
            <p:nvPr/>
          </p:nvGrpSpPr>
          <p:grpSpPr>
            <a:xfrm>
              <a:off x="7654819" y="438397"/>
              <a:ext cx="1331272" cy="2656719"/>
              <a:chOff x="7388309" y="148912"/>
              <a:chExt cx="1331272" cy="2656719"/>
            </a:xfrm>
          </p:grpSpPr>
          <p:pic>
            <p:nvPicPr>
              <p:cNvPr id="11" name="Picture 10"/>
              <p:cNvPicPr preferRelativeResize="0">
                <a:picLocks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7423048" y="1021952"/>
                <a:ext cx="1280160" cy="843316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7388309" y="1952191"/>
                <a:ext cx="1280160" cy="853440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 preferRelativeResize="0">
                <a:picLocks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7439421" y="148912"/>
                <a:ext cx="1280160" cy="831685"/>
              </a:xfrm>
              <a:prstGeom prst="rect">
                <a:avLst/>
              </a:prstGeom>
            </p:spPr>
          </p:pic>
        </p:grpSp>
        <p:sp>
          <p:nvSpPr>
            <p:cNvPr id="51" name="Rectangle 50"/>
            <p:cNvSpPr/>
            <p:nvPr/>
          </p:nvSpPr>
          <p:spPr>
            <a:xfrm>
              <a:off x="6372714" y="91901"/>
              <a:ext cx="2610595" cy="317004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7336620" y="95920"/>
              <a:ext cx="8737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KLRG-1</a:t>
              </a:r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3785949" y="491665"/>
            <a:ext cx="2610595" cy="3176671"/>
            <a:chOff x="3785949" y="91900"/>
            <a:chExt cx="2610595" cy="3176671"/>
          </a:xfrm>
        </p:grpSpPr>
        <p:grpSp>
          <p:nvGrpSpPr>
            <p:cNvPr id="45" name="Group 44"/>
            <p:cNvGrpSpPr/>
            <p:nvPr/>
          </p:nvGrpSpPr>
          <p:grpSpPr>
            <a:xfrm>
              <a:off x="3807045" y="452106"/>
              <a:ext cx="1290441" cy="2673476"/>
              <a:chOff x="3545130" y="163171"/>
              <a:chExt cx="1290441" cy="2673476"/>
            </a:xfrm>
          </p:grpSpPr>
          <p:pic>
            <p:nvPicPr>
              <p:cNvPr id="6" name="Picture 5"/>
              <p:cNvPicPr preferRelativeResize="0">
                <a:picLocks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554946" y="1081025"/>
                <a:ext cx="1280160" cy="82296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3545130" y="1979761"/>
                <a:ext cx="1188720" cy="856886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 preferRelativeResize="0">
                <a:picLocks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555411" y="163171"/>
                <a:ext cx="1280160" cy="825869"/>
              </a:xfrm>
              <a:prstGeom prst="rect">
                <a:avLst/>
              </a:prstGeom>
            </p:spPr>
          </p:pic>
        </p:grpSp>
        <p:grpSp>
          <p:nvGrpSpPr>
            <p:cNvPr id="44" name="Group 43"/>
            <p:cNvGrpSpPr/>
            <p:nvPr/>
          </p:nvGrpSpPr>
          <p:grpSpPr>
            <a:xfrm>
              <a:off x="4998186" y="456641"/>
              <a:ext cx="1381837" cy="2684175"/>
              <a:chOff x="4736271" y="167706"/>
              <a:chExt cx="1381837" cy="268417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4783711" y="1079570"/>
                <a:ext cx="1330744" cy="825869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4736271" y="1988951"/>
                <a:ext cx="1280160" cy="862930"/>
              </a:xfrm>
              <a:prstGeom prst="rect">
                <a:avLst/>
              </a:prstGeom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4834056" y="167706"/>
                <a:ext cx="1284052" cy="802604"/>
              </a:xfrm>
              <a:prstGeom prst="rect">
                <a:avLst/>
              </a:prstGeom>
            </p:spPr>
          </p:pic>
        </p:grpSp>
        <p:sp>
          <p:nvSpPr>
            <p:cNvPr id="50" name="Rectangle 49"/>
            <p:cNvSpPr/>
            <p:nvPr/>
          </p:nvSpPr>
          <p:spPr>
            <a:xfrm>
              <a:off x="3785949" y="91900"/>
              <a:ext cx="2610595" cy="317667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757822" y="95920"/>
              <a:ext cx="6957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CD57</a:t>
              </a:r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8977751" y="491665"/>
            <a:ext cx="2647812" cy="3170753"/>
            <a:chOff x="8977751" y="91900"/>
            <a:chExt cx="2647812" cy="3170753"/>
          </a:xfrm>
        </p:grpSpPr>
        <p:grpSp>
          <p:nvGrpSpPr>
            <p:cNvPr id="59" name="Group 58"/>
            <p:cNvGrpSpPr/>
            <p:nvPr/>
          </p:nvGrpSpPr>
          <p:grpSpPr>
            <a:xfrm>
              <a:off x="8977751" y="457628"/>
              <a:ext cx="1293639" cy="2647622"/>
              <a:chOff x="8711241" y="171811"/>
              <a:chExt cx="1293639" cy="2647622"/>
            </a:xfrm>
          </p:grpSpPr>
          <p:pic>
            <p:nvPicPr>
              <p:cNvPr id="14" name="Picture 13"/>
              <p:cNvPicPr preferRelativeResize="0">
                <a:picLocks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8722504" y="1010149"/>
                <a:ext cx="1280160" cy="914400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 preferRelativeResize="0">
                <a:picLocks/>
              </p:cNvPicPr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8711241" y="1956246"/>
                <a:ext cx="1280160" cy="863187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 preferRelativeResize="0">
                <a:picLocks/>
              </p:cNvPicPr>
              <p:nvPr/>
            </p:nvPicPr>
            <p:blipFill>
              <a:blip r:embed="rId28"/>
              <a:stretch>
                <a:fillRect/>
              </a:stretch>
            </p:blipFill>
            <p:spPr>
              <a:xfrm>
                <a:off x="8724720" y="171811"/>
                <a:ext cx="1280160" cy="820051"/>
              </a:xfrm>
              <a:prstGeom prst="rect">
                <a:avLst/>
              </a:prstGeom>
            </p:spPr>
          </p:pic>
        </p:grpSp>
        <p:grpSp>
          <p:nvGrpSpPr>
            <p:cNvPr id="60" name="Group 59"/>
            <p:cNvGrpSpPr/>
            <p:nvPr/>
          </p:nvGrpSpPr>
          <p:grpSpPr>
            <a:xfrm>
              <a:off x="10237272" y="475433"/>
              <a:ext cx="1388291" cy="2596022"/>
              <a:chOff x="9970762" y="189616"/>
              <a:chExt cx="1388291" cy="2596022"/>
            </a:xfrm>
          </p:grpSpPr>
          <p:pic>
            <p:nvPicPr>
              <p:cNvPr id="15" name="Picture 14"/>
              <p:cNvPicPr>
                <a:picLocks noChangeAspect="1"/>
              </p:cNvPicPr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9970762" y="1072043"/>
                <a:ext cx="1354090" cy="843316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 preferRelativeResize="0">
                <a:picLocks/>
              </p:cNvPicPr>
              <p:nvPr/>
            </p:nvPicPr>
            <p:blipFill>
              <a:blip r:embed="rId30"/>
              <a:stretch>
                <a:fillRect/>
              </a:stretch>
            </p:blipFill>
            <p:spPr>
              <a:xfrm>
                <a:off x="9978230" y="1971660"/>
                <a:ext cx="1280160" cy="813978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10004963" y="189616"/>
                <a:ext cx="1354090" cy="802604"/>
              </a:xfrm>
              <a:prstGeom prst="rect">
                <a:avLst/>
              </a:prstGeom>
            </p:spPr>
          </p:pic>
        </p:grpSp>
        <p:sp>
          <p:nvSpPr>
            <p:cNvPr id="52" name="Rectangle 51"/>
            <p:cNvSpPr/>
            <p:nvPr/>
          </p:nvSpPr>
          <p:spPr>
            <a:xfrm>
              <a:off x="8984822" y="91900"/>
              <a:ext cx="2610595" cy="317075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9877153" y="95920"/>
              <a:ext cx="67316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TIGIT</a:t>
              </a:r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2693434" y="4025983"/>
            <a:ext cx="8104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Isotype</a:t>
            </a:r>
            <a:endParaRPr lang="en-US" sz="16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2588514" y="4840063"/>
            <a:ext cx="9963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D4 blue</a:t>
            </a:r>
          </a:p>
          <a:p>
            <a:r>
              <a:rPr lang="en-US" sz="1600" b="1" dirty="0" smtClean="0"/>
              <a:t>CD8 pink</a:t>
            </a:r>
            <a:endParaRPr lang="en-US" sz="16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489179" y="5919687"/>
            <a:ext cx="11462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/>
              <a:t>Maturation</a:t>
            </a:r>
          </a:p>
          <a:p>
            <a:pPr algn="ctr"/>
            <a:r>
              <a:rPr lang="en-US" sz="1600" b="1" dirty="0" smtClean="0"/>
              <a:t>subset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690248" y="79674"/>
            <a:ext cx="3886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1. Gating Strategy</a:t>
            </a:r>
            <a:endParaRPr lang="en-US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353813" y="487070"/>
            <a:ext cx="473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B</a:t>
            </a:r>
            <a:endParaRPr lang="en-US" b="1"/>
          </a:p>
        </p:txBody>
      </p:sp>
      <p:sp>
        <p:nvSpPr>
          <p:cNvPr id="71" name="TextBox 70"/>
          <p:cNvSpPr txBox="1"/>
          <p:nvPr/>
        </p:nvSpPr>
        <p:spPr>
          <a:xfrm>
            <a:off x="2326602" y="4000894"/>
            <a:ext cx="453359" cy="3827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28845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Widescreen</PresentationFormat>
  <Paragraphs>2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21-01-14T19:02:40Z</dcterms:created>
  <dcterms:modified xsi:type="dcterms:W3CDTF">2021-01-14T19:03:01Z</dcterms:modified>
</cp:coreProperties>
</file>